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1" r:id="rId2"/>
  </p:sldIdLst>
  <p:sldSz cx="6858000" cy="9144000" type="screen4x3"/>
  <p:notesSz cx="6886575" cy="100171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  <a:srgbClr val="FF66CC"/>
    <a:srgbClr val="00CC00"/>
    <a:srgbClr val="FF3399"/>
    <a:srgbClr val="CC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rivastava Kirtiman" userId="3a11dbff-4250-4987-b0fd-bdb4aec8e4f4" providerId="ADAL" clId="{DEE5BF1C-57D8-491E-881F-1CA54F45D2E5}"/>
    <pc:docChg chg="delSld">
      <pc:chgData name="Srivastava Kirtiman" userId="3a11dbff-4250-4987-b0fd-bdb4aec8e4f4" providerId="ADAL" clId="{DEE5BF1C-57D8-491E-881F-1CA54F45D2E5}" dt="2023-09-26T05:39:39.206" v="0" actId="47"/>
      <pc:docMkLst>
        <pc:docMk/>
      </pc:docMkLst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1259959854" sldId="256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2763233914" sldId="261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1039223786" sldId="262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848410283" sldId="263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427346780" sldId="266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2148471778" sldId="267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2926218724" sldId="270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1877115284" sldId="271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2543658035" sldId="272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1539398957" sldId="273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237047004" sldId="274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392886559" sldId="275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404787500" sldId="276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1135332824" sldId="277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655190538" sldId="279"/>
        </pc:sldMkLst>
      </pc:sldChg>
      <pc:sldChg chg="del">
        <pc:chgData name="Srivastava Kirtiman" userId="3a11dbff-4250-4987-b0fd-bdb4aec8e4f4" providerId="ADAL" clId="{DEE5BF1C-57D8-491E-881F-1CA54F45D2E5}" dt="2023-09-26T05:39:39.206" v="0" actId="47"/>
        <pc:sldMkLst>
          <pc:docMk/>
          <pc:sldMk cId="3594146164" sldId="28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324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7396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48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1453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79262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646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3432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85821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1708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7856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580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53500-18EA-4924-9C64-6B988527CE39}" type="datetimeFigureOut">
              <a:rPr lang="en-GB" smtClean="0"/>
              <a:t>26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9153D-DE71-4D11-9A60-B75D77B7B4C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803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F81BCC8D-F787-40CE-A20E-EB27A630D1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4520665"/>
              </p:ext>
            </p:extLst>
          </p:nvPr>
        </p:nvGraphicFramePr>
        <p:xfrm>
          <a:off x="689105" y="665402"/>
          <a:ext cx="5856661" cy="1681310"/>
        </p:xfrm>
        <a:graphic>
          <a:graphicData uri="http://schemas.openxmlformats.org/drawingml/2006/table">
            <a:tbl>
              <a:tblPr firstRow="1">
                <a:tableStyleId>{073A0DAA-6AF3-43AB-8588-CEC1D06C72B9}</a:tableStyleId>
              </a:tblPr>
              <a:tblGrid>
                <a:gridCol w="1414722">
                  <a:extLst>
                    <a:ext uri="{9D8B030D-6E8A-4147-A177-3AD203B41FA5}">
                      <a16:colId xmlns:a16="http://schemas.microsoft.com/office/drawing/2014/main" val="4186163487"/>
                    </a:ext>
                  </a:extLst>
                </a:gridCol>
                <a:gridCol w="2144788">
                  <a:extLst>
                    <a:ext uri="{9D8B030D-6E8A-4147-A177-3AD203B41FA5}">
                      <a16:colId xmlns:a16="http://schemas.microsoft.com/office/drawing/2014/main" val="2468562528"/>
                    </a:ext>
                  </a:extLst>
                </a:gridCol>
                <a:gridCol w="2297151">
                  <a:extLst>
                    <a:ext uri="{9D8B030D-6E8A-4147-A177-3AD203B41FA5}">
                      <a16:colId xmlns:a16="http://schemas.microsoft.com/office/drawing/2014/main" val="3963073034"/>
                    </a:ext>
                  </a:extLst>
                </a:gridCol>
              </a:tblGrid>
              <a:tr h="336262"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s for qPC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3437230"/>
                  </a:ext>
                </a:extLst>
              </a:tr>
              <a:tr h="336262"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PB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GAAGGGAGAAAGAGGGAG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TAGTTTGAAGAGGTCAGGAG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1470741"/>
                  </a:ext>
                </a:extLst>
              </a:tr>
              <a:tr h="336262"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P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900" kern="1200" cap="all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tacaaccctgaagtgcttgat</a:t>
                      </a:r>
                      <a:endParaRPr lang="en-GB" sz="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kern="1200" cap="all" dirty="0" err="1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atctgcagacagacactgg</a:t>
                      </a:r>
                      <a:endParaRPr lang="en-GB" sz="9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0779317"/>
                  </a:ext>
                </a:extLst>
              </a:tr>
              <a:tr h="336262">
                <a:tc>
                  <a:txBody>
                    <a:bodyPr/>
                    <a:lstStyle/>
                    <a:p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5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TGACGGAGGTTGTGAG</a:t>
                      </a:r>
                      <a:endParaRPr lang="en-GB" sz="9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n-NO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ATGATGGTGAGGATGGG</a:t>
                      </a:r>
                      <a:endParaRPr lang="en-GB" sz="900" kern="12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0836030"/>
                  </a:ext>
                </a:extLst>
              </a:tr>
              <a:tr h="336262">
                <a:tc>
                  <a:txBody>
                    <a:bodyPr/>
                    <a:lstStyle/>
                    <a:p>
                      <a:r>
                        <a:rPr lang="en-GB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B</a:t>
                      </a:r>
                      <a:endPara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TTGAGGTGGACGGCAAG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GB" sz="900" b="0" i="0" u="none" strike="noStrike" kern="1200" baseline="0" dirty="0">
                          <a:solidFill>
                            <a:schemeClr val="dk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GGCACATTGGGACAGAAG</a:t>
                      </a:r>
                      <a:endParaRPr lang="en-GB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342105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F359C75-F165-4E28-B790-539755B7EF42}"/>
              </a:ext>
            </a:extLst>
          </p:cNvPr>
          <p:cNvSpPr txBox="1"/>
          <p:nvPr/>
        </p:nvSpPr>
        <p:spPr>
          <a:xfrm>
            <a:off x="66100" y="22033"/>
            <a:ext cx="22841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41658756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39</TotalTime>
  <Words>20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Queen Mary University of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rtiman Srivastava</dc:creator>
  <cp:lastModifiedBy>Srivastava Kirtiman</cp:lastModifiedBy>
  <cp:revision>224</cp:revision>
  <cp:lastPrinted>2020-11-17T09:46:46Z</cp:lastPrinted>
  <dcterms:created xsi:type="dcterms:W3CDTF">2019-12-09T13:40:55Z</dcterms:created>
  <dcterms:modified xsi:type="dcterms:W3CDTF">2023-09-26T05:39:42Z</dcterms:modified>
</cp:coreProperties>
</file>